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7"/>
  </p:notesMasterIdLst>
  <p:sldIdLst>
    <p:sldId id="260" r:id="rId2"/>
    <p:sldId id="261" r:id="rId3"/>
    <p:sldId id="262" r:id="rId4"/>
    <p:sldId id="263" r:id="rId5"/>
    <p:sldId id="264" r:id="rId6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098">
          <p15:clr>
            <a:srgbClr val="747775"/>
          </p15:clr>
        </p15:guide>
        <p15:guide id="2" pos="4680">
          <p15:clr>
            <a:srgbClr val="747775"/>
          </p15:clr>
        </p15:guide>
        <p15:guide id="3" orient="horz" pos="575">
          <p15:clr>
            <a:srgbClr val="747775"/>
          </p15:clr>
        </p15:guide>
        <p15:guide id="4" orient="horz" pos="1999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0648F669-B1F4-4D49-AF25-6D9E273F142D}">
  <a:tblStyle styleId="{0648F669-B1F4-4D49-AF25-6D9E273F142D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20"/>
    <p:restoredTop sz="94694"/>
  </p:normalViewPr>
  <p:slideViewPr>
    <p:cSldViewPr snapToGrid="0">
      <p:cViewPr varScale="1">
        <p:scale>
          <a:sx n="161" d="100"/>
          <a:sy n="161" d="100"/>
        </p:scale>
        <p:origin x="368" y="200"/>
      </p:cViewPr>
      <p:guideLst>
        <p:guide orient="horz" pos="3098"/>
        <p:guide pos="4680"/>
        <p:guide orient="horz" pos="575"/>
        <p:guide orient="horz" pos="19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ujii,Marina" userId="S::marfuj@colostate.edu::12fd1f01-136a-4a50-93e0-a08a51b08922" providerId="AD" clId="Web-{DF135608-14D1-917B-FF06-A87DC092851E}"/>
    <pc:docChg chg="modSld">
      <pc:chgData name="Fujii,Marina" userId="S::marfuj@colostate.edu::12fd1f01-136a-4a50-93e0-a08a51b08922" providerId="AD" clId="Web-{DF135608-14D1-917B-FF06-A87DC092851E}" dt="2025-07-24T19:54:49.866" v="0" actId="1076"/>
      <pc:docMkLst>
        <pc:docMk/>
      </pc:docMkLst>
      <pc:sldChg chg="modSp">
        <pc:chgData name="Fujii,Marina" userId="S::marfuj@colostate.edu::12fd1f01-136a-4a50-93e0-a08a51b08922" providerId="AD" clId="Web-{DF135608-14D1-917B-FF06-A87DC092851E}" dt="2025-07-24T19:54:49.866" v="0" actId="1076"/>
        <pc:sldMkLst>
          <pc:docMk/>
          <pc:sldMk cId="0" sldId="259"/>
        </pc:sldMkLst>
        <pc:picChg chg="mod">
          <ac:chgData name="Fujii,Marina" userId="S::marfuj@colostate.edu::12fd1f01-136a-4a50-93e0-a08a51b08922" providerId="AD" clId="Web-{DF135608-14D1-917B-FF06-A87DC092851E}" dt="2025-07-24T19:54:49.866" v="0" actId="1076"/>
          <ac:picMkLst>
            <pc:docMk/>
            <pc:sldMk cId="0" sldId="259"/>
            <ac:picMk id="4" creationId="{A81C3775-3106-91F1-912C-6FB126FDA400}"/>
          </ac:picMkLst>
        </pc:picChg>
      </pc:sldChg>
    </pc:docChg>
  </pc:docChgLst>
  <pc:docChgLst>
    <pc:chgData name="Fujii,Marina" userId="S::marfuj@colostate.edu::12fd1f01-136a-4a50-93e0-a08a51b08922" providerId="AD" clId="Web-{1C9E41A4-51D4-3D79-69BC-E8D19927EC74}"/>
    <pc:docChg chg="modSld">
      <pc:chgData name="Fujii,Marina" userId="S::marfuj@colostate.edu::12fd1f01-136a-4a50-93e0-a08a51b08922" providerId="AD" clId="Web-{1C9E41A4-51D4-3D79-69BC-E8D19927EC74}" dt="2025-07-22T16:59:31.720" v="10" actId="14100"/>
      <pc:docMkLst>
        <pc:docMk/>
      </pc:docMkLst>
      <pc:sldChg chg="addSp delSp modSp">
        <pc:chgData name="Fujii,Marina" userId="S::marfuj@colostate.edu::12fd1f01-136a-4a50-93e0-a08a51b08922" providerId="AD" clId="Web-{1C9E41A4-51D4-3D79-69BC-E8D19927EC74}" dt="2025-07-22T16:59:31.720" v="10" actId="14100"/>
        <pc:sldMkLst>
          <pc:docMk/>
          <pc:sldMk cId="0" sldId="257"/>
        </pc:sldMkLst>
        <pc:picChg chg="add mod">
          <ac:chgData name="Fujii,Marina" userId="S::marfuj@colostate.edu::12fd1f01-136a-4a50-93e0-a08a51b08922" providerId="AD" clId="Web-{1C9E41A4-51D4-3D79-69BC-E8D19927EC74}" dt="2025-07-22T16:59:31.720" v="10" actId="14100"/>
          <ac:picMkLst>
            <pc:docMk/>
            <pc:sldMk cId="0" sldId="257"/>
            <ac:picMk id="3" creationId="{2F781A2F-7D79-1640-E746-F277B82C9FDF}"/>
          </ac:picMkLst>
        </pc:picChg>
      </pc:sldChg>
    </pc:docChg>
  </pc:docChgLst>
  <pc:docChgLst>
    <pc:chgData name="Fujii,Marina" userId="S::marfuj@colostate.edu::12fd1f01-136a-4a50-93e0-a08a51b08922" providerId="AD" clId="Web-{B45CC079-E009-47A3-A7D3-E48F7A492239}"/>
    <pc:docChg chg="addSld delSld modSld">
      <pc:chgData name="Fujii,Marina" userId="S::marfuj@colostate.edu::12fd1f01-136a-4a50-93e0-a08a51b08922" providerId="AD" clId="Web-{B45CC079-E009-47A3-A7D3-E48F7A492239}" dt="2025-07-21T19:59:27.759" v="25" actId="1076"/>
      <pc:docMkLst>
        <pc:docMk/>
      </pc:docMkLst>
      <pc:sldChg chg="addSp delSp modSp add del">
        <pc:chgData name="Fujii,Marina" userId="S::marfuj@colostate.edu::12fd1f01-136a-4a50-93e0-a08a51b08922" providerId="AD" clId="Web-{B45CC079-E009-47A3-A7D3-E48F7A492239}" dt="2025-07-21T19:57:06.937" v="18"/>
        <pc:sldMkLst>
          <pc:docMk/>
          <pc:sldMk cId="0" sldId="256"/>
        </pc:sldMkLst>
        <pc:picChg chg="add mod">
          <ac:chgData name="Fujii,Marina" userId="S::marfuj@colostate.edu::12fd1f01-136a-4a50-93e0-a08a51b08922" providerId="AD" clId="Web-{B45CC079-E009-47A3-A7D3-E48F7A492239}" dt="2025-07-21T19:53:49.923" v="7" actId="14100"/>
          <ac:picMkLst>
            <pc:docMk/>
            <pc:sldMk cId="0" sldId="256"/>
            <ac:picMk id="3" creationId="{8C2DBC7C-CAAB-F704-5E54-D4292CCEAFE6}"/>
          </ac:picMkLst>
        </pc:picChg>
      </pc:sldChg>
      <pc:sldChg chg="addSp delSp modSp">
        <pc:chgData name="Fujii,Marina" userId="S::marfuj@colostate.edu::12fd1f01-136a-4a50-93e0-a08a51b08922" providerId="AD" clId="Web-{B45CC079-E009-47A3-A7D3-E48F7A492239}" dt="2025-07-21T19:57:11.328" v="19"/>
        <pc:sldMkLst>
          <pc:docMk/>
          <pc:sldMk cId="0" sldId="259"/>
        </pc:sldMkLst>
        <pc:picChg chg="add mod">
          <ac:chgData name="Fujii,Marina" userId="S::marfuj@colostate.edu::12fd1f01-136a-4a50-93e0-a08a51b08922" providerId="AD" clId="Web-{B45CC079-E009-47A3-A7D3-E48F7A492239}" dt="2025-07-21T19:56:52.998" v="17" actId="1076"/>
          <ac:picMkLst>
            <pc:docMk/>
            <pc:sldMk cId="0" sldId="259"/>
            <ac:picMk id="4" creationId="{A81C3775-3106-91F1-912C-6FB126FDA400}"/>
          </ac:picMkLst>
        </pc:picChg>
      </pc:sldChg>
      <pc:sldChg chg="addSp delSp modSp">
        <pc:chgData name="Fujii,Marina" userId="S::marfuj@colostate.edu::12fd1f01-136a-4a50-93e0-a08a51b08922" providerId="AD" clId="Web-{B45CC079-E009-47A3-A7D3-E48F7A492239}" dt="2025-07-21T19:59:27.759" v="25" actId="1076"/>
        <pc:sldMkLst>
          <pc:docMk/>
          <pc:sldMk cId="0" sldId="264"/>
        </pc:sldMkLst>
        <pc:picChg chg="add mod">
          <ac:chgData name="Fujii,Marina" userId="S::marfuj@colostate.edu::12fd1f01-136a-4a50-93e0-a08a51b08922" providerId="AD" clId="Web-{B45CC079-E009-47A3-A7D3-E48F7A492239}" dt="2025-07-21T19:59:27.759" v="25" actId="1076"/>
          <ac:picMkLst>
            <pc:docMk/>
            <pc:sldMk cId="0" sldId="264"/>
            <ac:picMk id="3" creationId="{0D0C67C7-AD33-9D9C-E432-A85EBE50DDA5}"/>
          </ac:picMkLst>
        </pc:picChg>
      </pc:sldChg>
    </pc:docChg>
  </pc:docChgLst>
  <pc:docChgLst>
    <pc:chgData name="Geiss,Brian" userId="05aeaf06-8ca3-4ac5-bbb3-fb9e4202ea9e" providerId="ADAL" clId="{E36DE117-E3DF-0642-B9FA-CB8C757DA549}"/>
    <pc:docChg chg="custSel modSld">
      <pc:chgData name="Geiss,Brian" userId="05aeaf06-8ca3-4ac5-bbb3-fb9e4202ea9e" providerId="ADAL" clId="{E36DE117-E3DF-0642-B9FA-CB8C757DA549}" dt="2025-07-12T12:38:19.521" v="288" actId="1076"/>
      <pc:docMkLst>
        <pc:docMk/>
      </pc:docMkLst>
      <pc:sldChg chg="addSp modSp mod modNotes">
        <pc:chgData name="Geiss,Brian" userId="05aeaf06-8ca3-4ac5-bbb3-fb9e4202ea9e" providerId="ADAL" clId="{E36DE117-E3DF-0642-B9FA-CB8C757DA549}" dt="2025-07-12T12:35:05.661" v="155" actId="1076"/>
        <pc:sldMkLst>
          <pc:docMk/>
          <pc:sldMk cId="0" sldId="256"/>
        </pc:sldMkLst>
      </pc:sldChg>
      <pc:sldChg chg="addSp delSp modSp mod modNotes">
        <pc:chgData name="Geiss,Brian" userId="05aeaf06-8ca3-4ac5-bbb3-fb9e4202ea9e" providerId="ADAL" clId="{E36DE117-E3DF-0642-B9FA-CB8C757DA549}" dt="2025-07-12T12:35:39.586" v="158"/>
        <pc:sldMkLst>
          <pc:docMk/>
          <pc:sldMk cId="0" sldId="257"/>
        </pc:sldMkLst>
      </pc:sldChg>
      <pc:sldChg chg="addSp modSp mod modNotes">
        <pc:chgData name="Geiss,Brian" userId="05aeaf06-8ca3-4ac5-bbb3-fb9e4202ea9e" providerId="ADAL" clId="{E36DE117-E3DF-0642-B9FA-CB8C757DA549}" dt="2025-07-12T12:36:45.180" v="253" actId="1076"/>
        <pc:sldMkLst>
          <pc:docMk/>
          <pc:sldMk cId="0" sldId="259"/>
        </pc:sldMkLst>
      </pc:sldChg>
      <pc:sldChg chg="addSp modSp mod modNotes">
        <pc:chgData name="Geiss,Brian" userId="05aeaf06-8ca3-4ac5-bbb3-fb9e4202ea9e" providerId="ADAL" clId="{E36DE117-E3DF-0642-B9FA-CB8C757DA549}" dt="2025-07-12T12:38:19.521" v="288" actId="1076"/>
        <pc:sldMkLst>
          <pc:docMk/>
          <pc:sldMk cId="0" sldId="264"/>
        </pc:sldMkLst>
      </pc:sldChg>
    </pc:docChg>
  </pc:docChgLst>
  <pc:docChgLst>
    <pc:chgData name="Sanchez-Vargas,Irma" userId="S::irsava9@colostate.edu::b84f5ffa-02d5-4a87-ac86-c4e1fce68f3a" providerId="AD" clId="Web-{D495F9E8-AEA5-3C5B-4FBA-47C43FEF633B}"/>
    <pc:docChg chg="modSld">
      <pc:chgData name="Sanchez-Vargas,Irma" userId="S::irsava9@colostate.edu::b84f5ffa-02d5-4a87-ac86-c4e1fce68f3a" providerId="AD" clId="Web-{D495F9E8-AEA5-3C5B-4FBA-47C43FEF633B}" dt="2025-07-22T20:17:07.260" v="0" actId="1076"/>
      <pc:docMkLst>
        <pc:docMk/>
      </pc:docMkLst>
      <pc:sldChg chg="modSp">
        <pc:chgData name="Sanchez-Vargas,Irma" userId="S::irsava9@colostate.edu::b84f5ffa-02d5-4a87-ac86-c4e1fce68f3a" providerId="AD" clId="Web-{D495F9E8-AEA5-3C5B-4FBA-47C43FEF633B}" dt="2025-07-22T20:17:07.260" v="0" actId="1076"/>
        <pc:sldMkLst>
          <pc:docMk/>
          <pc:sldMk cId="0" sldId="259"/>
        </pc:sldMkLst>
        <pc:picChg chg="mod">
          <ac:chgData name="Sanchez-Vargas,Irma" userId="S::irsava9@colostate.edu::b84f5ffa-02d5-4a87-ac86-c4e1fce68f3a" providerId="AD" clId="Web-{D495F9E8-AEA5-3C5B-4FBA-47C43FEF633B}" dt="2025-07-22T20:17:07.260" v="0" actId="1076"/>
          <ac:picMkLst>
            <pc:docMk/>
            <pc:sldMk cId="0" sldId="259"/>
            <ac:picMk id="4" creationId="{A81C3775-3106-91F1-912C-6FB126FDA400}"/>
          </ac:picMkLst>
        </pc:picChg>
      </pc:sldChg>
    </pc:docChg>
  </pc:docChgLst>
  <pc:docChgLst>
    <pc:chgData name="Geiss,Brian" userId="05aeaf06-8ca3-4ac5-bbb3-fb9e4202ea9e" providerId="ADAL" clId="{825FE496-7237-3A4D-A056-312C288B9BA2}"/>
    <pc:docChg chg="modSld">
      <pc:chgData name="Geiss,Brian" userId="05aeaf06-8ca3-4ac5-bbb3-fb9e4202ea9e" providerId="ADAL" clId="{825FE496-7237-3A4D-A056-312C288B9BA2}" dt="2025-07-28T14:03:02.401" v="3559" actId="962"/>
      <pc:docMkLst>
        <pc:docMk/>
      </pc:docMkLst>
      <pc:sldChg chg="modSp mod">
        <pc:chgData name="Geiss,Brian" userId="05aeaf06-8ca3-4ac5-bbb3-fb9e4202ea9e" providerId="ADAL" clId="{825FE496-7237-3A4D-A056-312C288B9BA2}" dt="2025-07-28T14:01:06.184" v="3487" actId="962"/>
        <pc:sldMkLst>
          <pc:docMk/>
          <pc:sldMk cId="0" sldId="256"/>
        </pc:sldMkLst>
        <pc:picChg chg="mod">
          <ac:chgData name="Geiss,Brian" userId="05aeaf06-8ca3-4ac5-bbb3-fb9e4202ea9e" providerId="ADAL" clId="{825FE496-7237-3A4D-A056-312C288B9BA2}" dt="2025-07-28T14:01:06.184" v="3487" actId="962"/>
          <ac:picMkLst>
            <pc:docMk/>
            <pc:sldMk cId="0" sldId="256"/>
            <ac:picMk id="3" creationId="{8C2DBC7C-CAAB-F704-5E54-D4292CCEAFE6}"/>
          </ac:picMkLst>
        </pc:picChg>
      </pc:sldChg>
      <pc:sldChg chg="modSp mod">
        <pc:chgData name="Geiss,Brian" userId="05aeaf06-8ca3-4ac5-bbb3-fb9e4202ea9e" providerId="ADAL" clId="{825FE496-7237-3A4D-A056-312C288B9BA2}" dt="2025-07-28T13:52:53.322" v="1051" actId="962"/>
        <pc:sldMkLst>
          <pc:docMk/>
          <pc:sldMk cId="0" sldId="257"/>
        </pc:sldMkLst>
        <pc:picChg chg="mod">
          <ac:chgData name="Geiss,Brian" userId="05aeaf06-8ca3-4ac5-bbb3-fb9e4202ea9e" providerId="ADAL" clId="{825FE496-7237-3A4D-A056-312C288B9BA2}" dt="2025-07-28T13:52:53.322" v="1051" actId="962"/>
          <ac:picMkLst>
            <pc:docMk/>
            <pc:sldMk cId="0" sldId="257"/>
            <ac:picMk id="3" creationId="{2F781A2F-7D79-1640-E746-F277B82C9FDF}"/>
          </ac:picMkLst>
        </pc:picChg>
      </pc:sldChg>
      <pc:sldChg chg="modSp mod">
        <pc:chgData name="Geiss,Brian" userId="05aeaf06-8ca3-4ac5-bbb3-fb9e4202ea9e" providerId="ADAL" clId="{825FE496-7237-3A4D-A056-312C288B9BA2}" dt="2025-07-28T14:02:15.640" v="3517" actId="962"/>
        <pc:sldMkLst>
          <pc:docMk/>
          <pc:sldMk cId="0" sldId="258"/>
        </pc:sldMkLst>
        <pc:picChg chg="mod">
          <ac:chgData name="Geiss,Brian" userId="05aeaf06-8ca3-4ac5-bbb3-fb9e4202ea9e" providerId="ADAL" clId="{825FE496-7237-3A4D-A056-312C288B9BA2}" dt="2025-07-28T14:02:15.640" v="3517" actId="962"/>
          <ac:picMkLst>
            <pc:docMk/>
            <pc:sldMk cId="0" sldId="258"/>
            <ac:picMk id="68" creationId="{00000000-0000-0000-0000-000000000000}"/>
          </ac:picMkLst>
        </pc:picChg>
      </pc:sldChg>
      <pc:sldChg chg="modSp mod">
        <pc:chgData name="Geiss,Brian" userId="05aeaf06-8ca3-4ac5-bbb3-fb9e4202ea9e" providerId="ADAL" clId="{825FE496-7237-3A4D-A056-312C288B9BA2}" dt="2025-07-28T14:03:02.401" v="3559" actId="962"/>
        <pc:sldMkLst>
          <pc:docMk/>
          <pc:sldMk cId="0" sldId="259"/>
        </pc:sldMkLst>
        <pc:picChg chg="mod">
          <ac:chgData name="Geiss,Brian" userId="05aeaf06-8ca3-4ac5-bbb3-fb9e4202ea9e" providerId="ADAL" clId="{825FE496-7237-3A4D-A056-312C288B9BA2}" dt="2025-07-28T14:03:02.401" v="3559" actId="962"/>
          <ac:picMkLst>
            <pc:docMk/>
            <pc:sldMk cId="0" sldId="259"/>
            <ac:picMk id="4" creationId="{A81C3775-3106-91F1-912C-6FB126FDA400}"/>
          </ac:picMkLst>
        </pc:picChg>
      </pc:sldChg>
      <pc:sldChg chg="modSp mod">
        <pc:chgData name="Geiss,Brian" userId="05aeaf06-8ca3-4ac5-bbb3-fb9e4202ea9e" providerId="ADAL" clId="{825FE496-7237-3A4D-A056-312C288B9BA2}" dt="2025-07-28T13:57:23.392" v="2403" actId="962"/>
        <pc:sldMkLst>
          <pc:docMk/>
          <pc:sldMk cId="0" sldId="260"/>
        </pc:sldMkLst>
        <pc:graphicFrameChg chg="mod">
          <ac:chgData name="Geiss,Brian" userId="05aeaf06-8ca3-4ac5-bbb3-fb9e4202ea9e" providerId="ADAL" clId="{825FE496-7237-3A4D-A056-312C288B9BA2}" dt="2025-07-28T13:57:23.392" v="2403" actId="962"/>
          <ac:graphicFrameMkLst>
            <pc:docMk/>
            <pc:sldMk cId="0" sldId="260"/>
            <ac:graphicFrameMk id="80" creationId="{00000000-0000-0000-0000-000000000000}"/>
          </ac:graphicFrameMkLst>
        </pc:graphicFrameChg>
      </pc:sldChg>
      <pc:sldChg chg="modSp mod">
        <pc:chgData name="Geiss,Brian" userId="05aeaf06-8ca3-4ac5-bbb3-fb9e4202ea9e" providerId="ADAL" clId="{825FE496-7237-3A4D-A056-312C288B9BA2}" dt="2025-07-28T13:57:55.921" v="2613" actId="962"/>
        <pc:sldMkLst>
          <pc:docMk/>
          <pc:sldMk cId="0" sldId="261"/>
        </pc:sldMkLst>
        <pc:graphicFrameChg chg="mod">
          <ac:chgData name="Geiss,Brian" userId="05aeaf06-8ca3-4ac5-bbb3-fb9e4202ea9e" providerId="ADAL" clId="{825FE496-7237-3A4D-A056-312C288B9BA2}" dt="2025-07-28T13:57:55.921" v="2613" actId="962"/>
          <ac:graphicFrameMkLst>
            <pc:docMk/>
            <pc:sldMk cId="0" sldId="261"/>
            <ac:graphicFrameMk id="86" creationId="{00000000-0000-0000-0000-000000000000}"/>
          </ac:graphicFrameMkLst>
        </pc:graphicFrameChg>
      </pc:sldChg>
      <pc:sldChg chg="modSp mod">
        <pc:chgData name="Geiss,Brian" userId="05aeaf06-8ca3-4ac5-bbb3-fb9e4202ea9e" providerId="ADAL" clId="{825FE496-7237-3A4D-A056-312C288B9BA2}" dt="2025-07-28T13:58:51.035" v="2965" actId="962"/>
        <pc:sldMkLst>
          <pc:docMk/>
          <pc:sldMk cId="0" sldId="262"/>
        </pc:sldMkLst>
        <pc:picChg chg="mod">
          <ac:chgData name="Geiss,Brian" userId="05aeaf06-8ca3-4ac5-bbb3-fb9e4202ea9e" providerId="ADAL" clId="{825FE496-7237-3A4D-A056-312C288B9BA2}" dt="2025-07-28T13:58:15.557" v="2729" actId="962"/>
          <ac:picMkLst>
            <pc:docMk/>
            <pc:sldMk cId="0" sldId="262"/>
            <ac:picMk id="91" creationId="{00000000-0000-0000-0000-000000000000}"/>
          </ac:picMkLst>
        </pc:picChg>
        <pc:picChg chg="mod">
          <ac:chgData name="Geiss,Brian" userId="05aeaf06-8ca3-4ac5-bbb3-fb9e4202ea9e" providerId="ADAL" clId="{825FE496-7237-3A4D-A056-312C288B9BA2}" dt="2025-07-28T13:58:51.035" v="2965" actId="962"/>
          <ac:picMkLst>
            <pc:docMk/>
            <pc:sldMk cId="0" sldId="262"/>
            <ac:picMk id="92" creationId="{00000000-0000-0000-0000-000000000000}"/>
          </ac:picMkLst>
        </pc:picChg>
        <pc:picChg chg="mod">
          <ac:chgData name="Geiss,Brian" userId="05aeaf06-8ca3-4ac5-bbb3-fb9e4202ea9e" providerId="ADAL" clId="{825FE496-7237-3A4D-A056-312C288B9BA2}" dt="2025-07-28T13:58:38.434" v="2855" actId="962"/>
          <ac:picMkLst>
            <pc:docMk/>
            <pc:sldMk cId="0" sldId="262"/>
            <ac:picMk id="95" creationId="{00000000-0000-0000-0000-000000000000}"/>
          </ac:picMkLst>
        </pc:picChg>
      </pc:sldChg>
      <pc:sldChg chg="modSp mod">
        <pc:chgData name="Geiss,Brian" userId="05aeaf06-8ca3-4ac5-bbb3-fb9e4202ea9e" providerId="ADAL" clId="{825FE496-7237-3A4D-A056-312C288B9BA2}" dt="2025-07-28T13:59:58.946" v="3337" actId="962"/>
        <pc:sldMkLst>
          <pc:docMk/>
          <pc:sldMk cId="0" sldId="263"/>
        </pc:sldMkLst>
        <pc:picChg chg="mod">
          <ac:chgData name="Geiss,Brian" userId="05aeaf06-8ca3-4ac5-bbb3-fb9e4202ea9e" providerId="ADAL" clId="{825FE496-7237-3A4D-A056-312C288B9BA2}" dt="2025-07-28T13:59:21.652" v="3117" actId="962"/>
          <ac:picMkLst>
            <pc:docMk/>
            <pc:sldMk cId="0" sldId="263"/>
            <ac:picMk id="103" creationId="{00000000-0000-0000-0000-000000000000}"/>
          </ac:picMkLst>
        </pc:picChg>
        <pc:picChg chg="mod">
          <ac:chgData name="Geiss,Brian" userId="05aeaf06-8ca3-4ac5-bbb3-fb9e4202ea9e" providerId="ADAL" clId="{825FE496-7237-3A4D-A056-312C288B9BA2}" dt="2025-07-28T13:59:58.946" v="3337" actId="962"/>
          <ac:picMkLst>
            <pc:docMk/>
            <pc:sldMk cId="0" sldId="263"/>
            <ac:picMk id="104" creationId="{00000000-0000-0000-0000-000000000000}"/>
          </ac:picMkLst>
        </pc:picChg>
      </pc:sldChg>
      <pc:sldChg chg="modSp mod">
        <pc:chgData name="Geiss,Brian" userId="05aeaf06-8ca3-4ac5-bbb3-fb9e4202ea9e" providerId="ADAL" clId="{825FE496-7237-3A4D-A056-312C288B9BA2}" dt="2025-07-28T14:00:24.753" v="3461" actId="962"/>
        <pc:sldMkLst>
          <pc:docMk/>
          <pc:sldMk cId="0" sldId="264"/>
        </pc:sldMkLst>
        <pc:picChg chg="mod">
          <ac:chgData name="Geiss,Brian" userId="05aeaf06-8ca3-4ac5-bbb3-fb9e4202ea9e" providerId="ADAL" clId="{825FE496-7237-3A4D-A056-312C288B9BA2}" dt="2025-07-28T14:00:24.753" v="3461" actId="962"/>
          <ac:picMkLst>
            <pc:docMk/>
            <pc:sldMk cId="0" sldId="264"/>
            <ac:picMk id="3" creationId="{0D0C67C7-AD33-9D9C-E432-A85EBE50DDA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Google Shape;76;g32a64b9f7f0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7" name="Google Shape;77;g32a64b9f7f0_1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36c7b37d8be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36c7b37d8be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g32be415c289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9" name="Google Shape;89;g32be415c289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32be415c289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0" name="Google Shape;100;g32be415c289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32a64b9f7f0_1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32a64b9f7f0_1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7"/>
          <p:cNvSpPr txBox="1">
            <a:spLocks noGrp="1"/>
          </p:cNvSpPr>
          <p:nvPr>
            <p:ph type="title"/>
          </p:nvPr>
        </p:nvSpPr>
        <p:spPr>
          <a:xfrm>
            <a:off x="228150" y="1574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820"/>
              <a:t>Supplementary Table 1. List of primers</a:t>
            </a:r>
            <a:endParaRPr sz="1820"/>
          </a:p>
        </p:txBody>
      </p:sp>
      <p:graphicFrame>
        <p:nvGraphicFramePr>
          <p:cNvPr id="80" name="Google Shape;80;p17" descr="Table showing sequences for different oligonucleotides used in this study. "/>
          <p:cNvGraphicFramePr/>
          <p:nvPr>
            <p:extLst>
              <p:ext uri="{D42A27DB-BD31-4B8C-83A1-F6EECF244321}">
                <p14:modId xmlns:p14="http://schemas.microsoft.com/office/powerpoint/2010/main" val="1431906188"/>
              </p:ext>
            </p:extLst>
          </p:nvPr>
        </p:nvGraphicFramePr>
        <p:xfrm>
          <a:off x="115713" y="1074200"/>
          <a:ext cx="8912575" cy="3392120"/>
        </p:xfrm>
        <a:graphic>
          <a:graphicData uri="http://schemas.openxmlformats.org/drawingml/2006/table">
            <a:tbl>
              <a:tblPr>
                <a:noFill/>
                <a:tableStyleId>{0648F669-B1F4-4D49-AF25-6D9E273F142D}</a:tableStyleId>
              </a:tblPr>
              <a:tblGrid>
                <a:gridCol w="2295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45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39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4323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010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/>
                        <a:t>Primer</a:t>
                      </a:r>
                      <a:endParaRPr sz="800" b="1"/>
                    </a:p>
                  </a:txBody>
                  <a:tcPr marL="63500" marR="63500" marT="63500" marB="63500"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/>
                        <a:t>sequence (5’ ➔ 3’)</a:t>
                      </a:r>
                      <a:endParaRPr sz="800" b="1"/>
                    </a:p>
                  </a:txBody>
                  <a:tcPr marL="63500" marR="63500" marT="63500" marB="63500"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en" sz="800" b="1">
                          <a:solidFill>
                            <a:schemeClr val="dk1"/>
                          </a:solidFill>
                        </a:rPr>
                        <a:t>Primer</a:t>
                      </a:r>
                      <a:endParaRPr sz="800" b="1"/>
                    </a:p>
                  </a:txBody>
                  <a:tcPr marL="63500" marR="63500" marT="63500" marB="63500"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en" sz="800" b="1">
                          <a:solidFill>
                            <a:schemeClr val="dk1"/>
                          </a:solidFill>
                        </a:rPr>
                        <a:t>sequence (5’ ➔ 3’)</a:t>
                      </a:r>
                      <a:endParaRPr sz="800" b="1"/>
                    </a:p>
                  </a:txBody>
                  <a:tcPr marL="91425" marR="91425" marT="91425" marB="91425"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637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1st fragment F/1st and 4th overlap PCR F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AGTAAATTTTGCGTGCTAATCGCTTG</a:t>
                      </a:r>
                      <a:endParaRPr sz="80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Backbone F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CGCGACAGACATGATAAGATACAT</a:t>
                      </a:r>
                      <a:endParaRPr sz="800">
                        <a:highlight>
                          <a:srgbClr val="FFFFFF"/>
                        </a:highlight>
                      </a:endParaRPr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052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1st fragment R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CATTCCACCTCGTCTGTAGACCC</a:t>
                      </a:r>
                      <a:endParaRPr sz="80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Backbone R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CAATGAATAATATGGCTAATGGCC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472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2nd fragment F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GGCATTGATCTCTCAGTGGTCG</a:t>
                      </a:r>
                      <a:endParaRPr sz="80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1 subcloning F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>
                          <a:solidFill>
                            <a:schemeClr val="dk1"/>
                          </a:solidFill>
                        </a:rPr>
                        <a:t>attagccatattattcattg</a:t>
                      </a:r>
                      <a:r>
                        <a:rPr lang="en" sz="800"/>
                        <a:t>TCAATATTGGCTATTGGCCATTGCA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38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2nd fragment R/1st overlap PCR R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GATCCAAGAAGTGGGCTTCATCC</a:t>
                      </a:r>
                      <a:endParaRPr sz="80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1 subcloning R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cttatcatgtctgtcgcgaGGCGTTCACTCCCAGCCACAAAAAGATGGTGCC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805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3rd fragment F/3rd overlap PCR F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dirty="0"/>
                        <a:t>ATCAGGAGCTCTCATTGACATCATG</a:t>
                      </a:r>
                      <a:endParaRPr sz="800" dirty="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2 subcloning F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attagccatattattcattgTTTGTGGCTGGGAGTGAACGCC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387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3rd fragment R</a:t>
                      </a:r>
                      <a:endParaRPr sz="800"/>
                    </a:p>
                  </a:txBody>
                  <a:tcPr marL="63500" marR="63500" marT="63500" marB="6350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GGAGCTTTCCCCTATGTCGCAC</a:t>
                      </a:r>
                      <a:endParaRPr sz="800"/>
                    </a:p>
                  </a:txBody>
                  <a:tcPr marL="0" marR="0" marT="91425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2 subcloning R</a:t>
                      </a:r>
                      <a:endParaRPr sz="800"/>
                    </a:p>
                  </a:txBody>
                  <a:tcPr marL="63500" marR="63500" marT="63500" marB="6350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cttatcatgtctgtcgcgaGGGCTCTTCTGGTATTGTCATCTGTG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802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4th fragment F/2nd overlap PCR F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GTGTTCACGTTGGAAACAATTCC</a:t>
                      </a:r>
                      <a:endParaRPr sz="800"/>
                    </a:p>
                  </a:txBody>
                  <a:tcPr marL="0" marR="0" marT="9525" marB="0" anchor="ctr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3 cloning F</a:t>
                      </a:r>
                      <a:endParaRPr sz="800"/>
                    </a:p>
                  </a:txBody>
                  <a:tcPr marL="63500" marR="63500" marT="63500" marB="63500" anchor="ctr"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>
                          <a:solidFill>
                            <a:schemeClr val="dk1"/>
                          </a:solidFill>
                        </a:rPr>
                        <a:t>attagccatattattcattg</a:t>
                      </a:r>
                      <a:r>
                        <a:rPr lang="en" sz="800"/>
                        <a:t>AGATGACAATACCAGAAGAGCCC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9700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4th fragment R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CACCACCTTGTGTCTGTAAGCAAG</a:t>
                      </a:r>
                      <a:endParaRPr sz="800"/>
                    </a:p>
                  </a:txBody>
                  <a:tcPr marL="0" marR="0" marT="9525" marB="0" anchor="ctr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3 cloning R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cttatcatgtctgtcgcgaCGCATCCCAAATCCACGACCGTTC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052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5th fragment F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CATCCTCGCTGAAGCAGTCATGAC</a:t>
                      </a:r>
                      <a:endParaRPr sz="800"/>
                    </a:p>
                  </a:txBody>
                  <a:tcPr marL="0" marR="0" marT="9525" marB="0" anchor="ctr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4 subcloning F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>
                          <a:solidFill>
                            <a:schemeClr val="dk1"/>
                          </a:solidFill>
                        </a:rPr>
                        <a:t>attagccatattattcattg</a:t>
                      </a:r>
                      <a:r>
                        <a:rPr lang="en" sz="800"/>
                        <a:t>AGGAACGGTCGTGGATTTGGGAT</a:t>
                      </a:r>
                      <a:endParaRPr sz="80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8875"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5th fragment R/2nd &amp; 3rd &amp; 4th overlap PCR R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9144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GGCGAACCTTGTTTGTGTTTGCAT</a:t>
                      </a:r>
                      <a:endParaRPr sz="800"/>
                    </a:p>
                  </a:txBody>
                  <a:tcPr marL="0" marR="0" marT="9525" marB="0" anchor="ctr"/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lasmid 4 subcloning R</a:t>
                      </a:r>
                      <a:endParaRPr sz="800"/>
                    </a:p>
                  </a:txBody>
                  <a:tcPr marL="63500" marR="63500" marT="63500" marB="63500" anchor="ctr">
                    <a:solidFill>
                      <a:srgbClr val="EFEFEF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dirty="0" err="1"/>
                        <a:t>tatcttatcatgtctgtcgcgaGTCCCATTCGCCATTACCGAGG</a:t>
                      </a:r>
                      <a:endParaRPr sz="800" dirty="0"/>
                    </a:p>
                  </a:txBody>
                  <a:tcPr marL="91425" marR="91425" marT="91425" marB="91425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8"/>
          <p:cNvSpPr txBox="1">
            <a:spLocks noGrp="1"/>
          </p:cNvSpPr>
          <p:nvPr>
            <p:ph type="title"/>
          </p:nvPr>
        </p:nvSpPr>
        <p:spPr>
          <a:xfrm>
            <a:off x="149500" y="0"/>
            <a:ext cx="8520600" cy="519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820"/>
              <a:t>Supplementary Table 2. List of viruses</a:t>
            </a:r>
            <a:endParaRPr sz="1820"/>
          </a:p>
        </p:txBody>
      </p:sp>
      <p:graphicFrame>
        <p:nvGraphicFramePr>
          <p:cNvPr id="86" name="Google Shape;86;p18" descr="Table showing NCBI Accession Numbers for all virus sequences used in this study. "/>
          <p:cNvGraphicFramePr/>
          <p:nvPr>
            <p:extLst>
              <p:ext uri="{D42A27DB-BD31-4B8C-83A1-F6EECF244321}">
                <p14:modId xmlns:p14="http://schemas.microsoft.com/office/powerpoint/2010/main" val="2297387331"/>
              </p:ext>
            </p:extLst>
          </p:nvPr>
        </p:nvGraphicFramePr>
        <p:xfrm>
          <a:off x="313075" y="519000"/>
          <a:ext cx="7751450" cy="4466800"/>
        </p:xfrm>
        <a:graphic>
          <a:graphicData uri="http://schemas.openxmlformats.org/drawingml/2006/table">
            <a:tbl>
              <a:tblPr>
                <a:noFill/>
                <a:tableStyleId>{0648F669-B1F4-4D49-AF25-6D9E273F142D}</a:tableStyleId>
              </a:tblPr>
              <a:tblGrid>
                <a:gridCol w="8604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787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016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94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6891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72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/>
                        <a:t>Abbreviation</a:t>
                      </a:r>
                      <a:endParaRPr sz="800" b="1"/>
                    </a:p>
                  </a:txBody>
                  <a:tcPr marL="0" marR="0" marT="0" marB="0" anchor="ctr"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/>
                        <a:t>Virus full name</a:t>
                      </a:r>
                      <a:endParaRPr sz="800" b="1"/>
                    </a:p>
                  </a:txBody>
                  <a:tcPr marL="0" marR="0" marT="0" marB="0" anchor="ctr"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en" sz="800" b="1">
                          <a:solidFill>
                            <a:schemeClr val="dk1"/>
                          </a:solidFill>
                        </a:rPr>
                        <a:t>NCBI accession number</a:t>
                      </a:r>
                      <a:endParaRPr sz="800" b="1"/>
                    </a:p>
                  </a:txBody>
                  <a:tcPr marL="0" marR="0" marT="0" marB="0" anchor="ctr"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/>
                        <a:t>Abbreviation</a:t>
                      </a:r>
                      <a:endParaRPr sz="800" b="1">
                        <a:solidFill>
                          <a:schemeClr val="dk1"/>
                        </a:solidFill>
                      </a:endParaRPr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b="1" dirty="0"/>
                        <a:t>Virus full name</a:t>
                      </a:r>
                      <a:endParaRPr sz="800" b="1" dirty="0">
                        <a:solidFill>
                          <a:schemeClr val="dk1"/>
                        </a:solidFill>
                      </a:endParaRPr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7B7B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100"/>
                        <a:buFont typeface="Arial"/>
                        <a:buNone/>
                      </a:pPr>
                      <a:r>
                        <a:rPr lang="en" sz="800" b="1">
                          <a:solidFill>
                            <a:schemeClr val="dk1"/>
                          </a:solidFill>
                        </a:rPr>
                        <a:t>NCBI accession number</a:t>
                      </a:r>
                      <a:endParaRPr sz="800" b="1">
                        <a:solidFill>
                          <a:schemeClr val="dk1"/>
                        </a:solidFill>
                      </a:endParaRPr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B7B7B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YF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yellow fever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2031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V2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gue virus 2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474.2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EP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epik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8719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V3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gue virus 3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475.2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ENT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Entebbe bat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Q720541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V4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gue virus 4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2640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OK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okoluk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26624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MODV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Modoc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3635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YOK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Yokose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5039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RBV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Rio Bravo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JQ582840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MVE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Murray Valley encephalitis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0943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APOV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Apoi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3676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USUV</a:t>
                      </a:r>
                      <a:endParaRPr sz="800"/>
                    </a:p>
                  </a:txBody>
                  <a:tcPr marL="0" marR="0" marT="0" marB="0" anchor="ctr"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Usutu virus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6551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OWV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Powassan virus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3687.1</a:t>
                      </a:r>
                      <a:endParaRPr sz="800"/>
                    </a:p>
                  </a:txBody>
                  <a:tcPr marL="0" marR="0" marT="0" marB="0" anchor="ctr">
                    <a:lnL w="119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JE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Japanese encephalitis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437.1</a:t>
                      </a:r>
                      <a:endParaRPr sz="800"/>
                    </a:p>
                  </a:txBody>
                  <a:tcPr marL="0" marR="0" marT="0" marB="0" anchor="ctr"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LGTV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Langat virus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3690.1</a:t>
                      </a:r>
                      <a:endParaRPr sz="800"/>
                    </a:p>
                  </a:txBody>
                  <a:tcPr marL="0" marR="0" marT="0" marB="0" anchor="ctr"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WN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West Nile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9942.1</a:t>
                      </a:r>
                      <a:endParaRPr sz="800"/>
                    </a:p>
                  </a:txBody>
                  <a:tcPr marL="0" marR="0" marT="0" marB="0" anchor="ctr"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OHFV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Omsk hemorrhagic fever virus</a:t>
                      </a:r>
                      <a:endParaRPr sz="800"/>
                    </a:p>
                  </a:txBody>
                  <a:tcPr marL="0" marR="0" marT="0" marB="0" anchor="ctr">
                    <a:lnL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5062.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LE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Saint Louis encephalitis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7580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BEV</a:t>
                      </a:r>
                      <a:endParaRPr sz="800"/>
                    </a:p>
                  </a:txBody>
                  <a:tcPr marL="0" marR="0" marT="0" marB="0" anchor="ctr"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tick-borne encephalitis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672.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ZIK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Zika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35889.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LI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louping ill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809.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436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V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dengue virus 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NC_001477.1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HCV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/>
                        <a:t>hepatitis C virus</a:t>
                      </a:r>
                      <a:endParaRPr sz="80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800" dirty="0"/>
                        <a:t>NC_004102.1</a:t>
                      </a:r>
                      <a:endParaRPr sz="800" dirty="0"/>
                    </a:p>
                  </a:txBody>
                  <a:tcPr marL="0" marR="0" marT="0" marB="0" anchor="ctr"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Google Shape;91;p19" descr="Image showing the structure of the ENTV 3' stem loop. "/>
          <p:cNvPicPr preferRelativeResize="0"/>
          <p:nvPr/>
        </p:nvPicPr>
        <p:blipFill rotWithShape="1">
          <a:blip r:embed="rId3">
            <a:alphaModFix/>
          </a:blip>
          <a:srcRect l="33629" r="49910"/>
          <a:stretch/>
        </p:blipFill>
        <p:spPr>
          <a:xfrm>
            <a:off x="2251644" y="1626773"/>
            <a:ext cx="1412654" cy="3516727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p19" descr="Image showing the structure of the WNV 3' stem loop. "/>
          <p:cNvPicPr preferRelativeResize="0"/>
          <p:nvPr/>
        </p:nvPicPr>
        <p:blipFill rotWithShape="1">
          <a:blip r:embed="rId4">
            <a:alphaModFix/>
          </a:blip>
          <a:srcRect l="35934" t="9394" r="43010" b="13032"/>
          <a:stretch/>
        </p:blipFill>
        <p:spPr>
          <a:xfrm>
            <a:off x="4941265" y="2070436"/>
            <a:ext cx="1199478" cy="2575711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p19"/>
          <p:cNvSpPr txBox="1"/>
          <p:nvPr/>
        </p:nvSpPr>
        <p:spPr>
          <a:xfrm>
            <a:off x="4865400" y="1294032"/>
            <a:ext cx="1351200" cy="4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>
                <a:solidFill>
                  <a:schemeClr val="dk1"/>
                </a:solidFill>
              </a:rPr>
              <a:t>WNV</a:t>
            </a:r>
            <a:endParaRPr sz="2000">
              <a:solidFill>
                <a:schemeClr val="dk1"/>
              </a:solidFill>
            </a:endParaRPr>
          </a:p>
        </p:txBody>
      </p:sp>
      <p:sp>
        <p:nvSpPr>
          <p:cNvPr id="94" name="Google Shape;94;p19"/>
          <p:cNvSpPr txBox="1"/>
          <p:nvPr/>
        </p:nvSpPr>
        <p:spPr>
          <a:xfrm>
            <a:off x="3580570" y="1262323"/>
            <a:ext cx="1351200" cy="4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>
                <a:solidFill>
                  <a:schemeClr val="dk1"/>
                </a:solidFill>
              </a:rPr>
              <a:t>YFV</a:t>
            </a:r>
            <a:endParaRPr sz="2000">
              <a:solidFill>
                <a:schemeClr val="dk1"/>
              </a:solidFill>
            </a:endParaRPr>
          </a:p>
        </p:txBody>
      </p:sp>
      <p:pic>
        <p:nvPicPr>
          <p:cNvPr id="95" name="Google Shape;95;p19" descr="Image showing the structure of the YFV 3' stem loop. "/>
          <p:cNvPicPr preferRelativeResize="0"/>
          <p:nvPr/>
        </p:nvPicPr>
        <p:blipFill rotWithShape="1">
          <a:blip r:embed="rId5">
            <a:alphaModFix/>
          </a:blip>
          <a:srcRect l="39983" t="8918" r="45416" b="10585"/>
          <a:stretch/>
        </p:blipFill>
        <p:spPr>
          <a:xfrm>
            <a:off x="3656428" y="1992593"/>
            <a:ext cx="1199478" cy="2709598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19"/>
          <p:cNvSpPr txBox="1">
            <a:spLocks noGrp="1"/>
          </p:cNvSpPr>
          <p:nvPr>
            <p:ph type="title"/>
          </p:nvPr>
        </p:nvSpPr>
        <p:spPr>
          <a:xfrm>
            <a:off x="146525" y="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820"/>
              <a:t>Supplementary Figure 1. The entire 3’ UTR was identified </a:t>
            </a:r>
            <a:endParaRPr sz="1820"/>
          </a:p>
        </p:txBody>
      </p:sp>
      <p:sp>
        <p:nvSpPr>
          <p:cNvPr id="97" name="Google Shape;97;p19"/>
          <p:cNvSpPr txBox="1"/>
          <p:nvPr/>
        </p:nvSpPr>
        <p:spPr>
          <a:xfrm>
            <a:off x="2282375" y="1267907"/>
            <a:ext cx="1351200" cy="42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000">
                <a:solidFill>
                  <a:schemeClr val="dk1"/>
                </a:solidFill>
              </a:rPr>
              <a:t>ENTV</a:t>
            </a:r>
            <a:endParaRPr sz="2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20"/>
          <p:cNvSpPr txBox="1">
            <a:spLocks noGrp="1"/>
          </p:cNvSpPr>
          <p:nvPr>
            <p:ph type="title"/>
          </p:nvPr>
        </p:nvSpPr>
        <p:spPr>
          <a:xfrm>
            <a:off x="146525" y="0"/>
            <a:ext cx="9304500" cy="1097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800"/>
              <a:t>Supplementary Figure 2. CT and ISE6 cells can support replication of other flaviviruses</a:t>
            </a:r>
            <a:endParaRPr sz="1800"/>
          </a:p>
        </p:txBody>
      </p:sp>
      <p:pic>
        <p:nvPicPr>
          <p:cNvPr id="103" name="Google Shape;103;p20" descr="Chart showing that ENVT and WNV can replicate in CT mosquito cells. 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14238" y="1457963"/>
            <a:ext cx="3009399" cy="23550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4" name="Google Shape;104;p20" descr="Chart showing that POWV (but not ENTV) can replicate in ISE6 tick cells. 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4047250" y="1512250"/>
            <a:ext cx="2894274" cy="224650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21"/>
          <p:cNvSpPr txBox="1">
            <a:spLocks noGrp="1"/>
          </p:cNvSpPr>
          <p:nvPr>
            <p:ph type="title"/>
          </p:nvPr>
        </p:nvSpPr>
        <p:spPr>
          <a:xfrm>
            <a:off x="146525" y="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990"/>
              <a:buNone/>
            </a:pPr>
            <a:r>
              <a:rPr lang="en" sz="1820"/>
              <a:t>Supplementary Figure 3. qRT-PCR standard curve </a:t>
            </a:r>
            <a:endParaRPr sz="1820"/>
          </a:p>
        </p:txBody>
      </p:sp>
      <p:pic>
        <p:nvPicPr>
          <p:cNvPr id="3" name="Picture 2" descr="Chart showing qPCR standard curve used in this study. ">
            <a:extLst>
              <a:ext uri="{FF2B5EF4-FFF2-40B4-BE49-F238E27FC236}">
                <a16:creationId xmlns:a16="http://schemas.microsoft.com/office/drawing/2014/main" id="{0D0C67C7-AD33-9D9C-E432-A85EBE50DD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008" y="955007"/>
            <a:ext cx="4445398" cy="369219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4</Words>
  <Application>Microsoft Macintosh PowerPoint</Application>
  <PresentationFormat>On-screen Show (16:9)</PresentationFormat>
  <Paragraphs>130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Arial</vt:lpstr>
      <vt:lpstr>Simple Light</vt:lpstr>
      <vt:lpstr>Supplementary Table 1. List of primers</vt:lpstr>
      <vt:lpstr>Supplementary Table 2. List of viruses</vt:lpstr>
      <vt:lpstr>Supplementary Figure 1. The entire 3’ UTR was identified </vt:lpstr>
      <vt:lpstr>Supplementary Figure 2. CT and ISE6 cells can support replication of other flaviviruses</vt:lpstr>
      <vt:lpstr>Supplementary Figure 3. qRT-PCR standard curve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Brian Geiss</cp:lastModifiedBy>
  <cp:revision>4</cp:revision>
  <dcterms:modified xsi:type="dcterms:W3CDTF">2025-07-29T14:27:57Z</dcterms:modified>
</cp:coreProperties>
</file>